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3" r:id="rId2"/>
  </p:sldIdLst>
  <p:sldSz cx="12192000" cy="6858000"/>
  <p:notesSz cx="9926638" cy="6797675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33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446" autoAdjust="0"/>
    <p:restoredTop sz="94660"/>
  </p:normalViewPr>
  <p:slideViewPr>
    <p:cSldViewPr snapToGrid="0">
      <p:cViewPr>
        <p:scale>
          <a:sx n="70" d="100"/>
          <a:sy n="70" d="100"/>
        </p:scale>
        <p:origin x="-432" y="-9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giora\AppData\Local\Microsoft\Windows\INetCache\Content.Outlook\SKVSTHX7\&#1490;&#1493;&#1491;&#1500;%20&#1514;&#1488;+&#1502;&#1505;&#1508;&#1512;%20&#1513;&#1499;&#1489;&#1493;&#1514;_%20(002)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\\bd-7-ivrb28\SHARE%20LAB\maya\&#1490;&#1493;&#1491;&#1500;%20&#1514;&#1488;+&#1502;&#1505;&#1508;&#1512;%20&#1513;&#1499;&#1489;&#1493;&#1514;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Users\smaya\Desktop\maya\&#1490;&#1493;&#1491;&#1500;%20&#1514;&#1488;+&#1502;&#1505;&#1508;&#1512;%20&#1513;&#1499;&#1489;&#1493;&#1514;.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2735210232718"/>
          <c:y val="7.9485076528007237E-2"/>
          <c:w val="0.79325100917403435"/>
          <c:h val="0.762171441224620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B7D-4EC2-93E8-9434F3E35DB3}"/>
              </c:ext>
            </c:extLst>
          </c:dPt>
          <c:dPt>
            <c:idx val="1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B7D-4EC2-93E8-9434F3E35DB3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B7D-4EC2-93E8-9434F3E35DB3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B7D-4EC2-93E8-9434F3E35DB3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CB7D-4EC2-93E8-9434F3E35DB3}"/>
              </c:ext>
            </c:extLst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CB7D-4EC2-93E8-9434F3E35DB3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CB7D-4EC2-93E8-9434F3E35DB3}"/>
              </c:ext>
            </c:extLst>
          </c:dPt>
          <c:dPt>
            <c:idx val="10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CB7D-4EC2-93E8-9434F3E35DB3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CB7D-4EC2-93E8-9434F3E35DB3}"/>
              </c:ext>
            </c:extLst>
          </c:dPt>
          <c:dPt>
            <c:idx val="13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CB7D-4EC2-93E8-9434F3E35DB3}"/>
              </c:ext>
            </c:extLst>
          </c:dPt>
          <c:errBars>
            <c:errBarType val="both"/>
            <c:errValType val="cust"/>
            <c:noEndCap val="0"/>
            <c:plus>
              <c:numRef>
                <c:f>September!$F$21:$F$34</c:f>
                <c:numCache>
                  <c:formatCode>General</c:formatCode>
                  <c:ptCount val="14"/>
                  <c:pt idx="0">
                    <c:v>1.6540999999999997</c:v>
                  </c:pt>
                  <c:pt idx="1">
                    <c:v>1.6544000000000025</c:v>
                  </c:pt>
                  <c:pt idx="3">
                    <c:v>1.9817999999999998</c:v>
                  </c:pt>
                  <c:pt idx="4">
                    <c:v>1.9817</c:v>
                  </c:pt>
                  <c:pt idx="6">
                    <c:v>2.7193000000000005</c:v>
                  </c:pt>
                  <c:pt idx="7">
                    <c:v>2.718399999999999</c:v>
                  </c:pt>
                  <c:pt idx="9">
                    <c:v>2.5028000000000006</c:v>
                  </c:pt>
                  <c:pt idx="10">
                    <c:v>2.5031000000000034</c:v>
                  </c:pt>
                  <c:pt idx="12">
                    <c:v>2.2734000000000023</c:v>
                  </c:pt>
                  <c:pt idx="13">
                    <c:v>2.2733999999999988</c:v>
                  </c:pt>
                </c:numCache>
              </c:numRef>
            </c:plus>
            <c:minus>
              <c:numRef>
                <c:f>September!$F$21:$F$34</c:f>
                <c:numCache>
                  <c:formatCode>General</c:formatCode>
                  <c:ptCount val="14"/>
                  <c:pt idx="0">
                    <c:v>1.6540999999999997</c:v>
                  </c:pt>
                  <c:pt idx="1">
                    <c:v>1.6544000000000025</c:v>
                  </c:pt>
                  <c:pt idx="3">
                    <c:v>1.9817999999999998</c:v>
                  </c:pt>
                  <c:pt idx="4">
                    <c:v>1.9817</c:v>
                  </c:pt>
                  <c:pt idx="6">
                    <c:v>2.7193000000000005</c:v>
                  </c:pt>
                  <c:pt idx="7">
                    <c:v>2.718399999999999</c:v>
                  </c:pt>
                  <c:pt idx="9">
                    <c:v>2.5028000000000006</c:v>
                  </c:pt>
                  <c:pt idx="10">
                    <c:v>2.5031000000000034</c:v>
                  </c:pt>
                  <c:pt idx="12">
                    <c:v>2.2734000000000023</c:v>
                  </c:pt>
                  <c:pt idx="13">
                    <c:v>2.27339999999999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ptember!$C$21:$C$34</c:f>
              <c:strCache>
                <c:ptCount val="13"/>
                <c:pt idx="0">
                  <c:v>Barnea</c:v>
                </c:pt>
                <c:pt idx="3">
                  <c:v>Picholine</c:v>
                </c:pt>
                <c:pt idx="6">
                  <c:v>Koroneiki</c:v>
                </c:pt>
                <c:pt idx="9">
                  <c:v>Souri</c:v>
                </c:pt>
                <c:pt idx="12">
                  <c:v>Coratina</c:v>
                </c:pt>
              </c:strCache>
            </c:strRef>
          </c:cat>
          <c:val>
            <c:numRef>
              <c:f>September!$E$21:$E$34</c:f>
              <c:numCache>
                <c:formatCode>General</c:formatCode>
                <c:ptCount val="14"/>
                <c:pt idx="0">
                  <c:v>25.029900000000001</c:v>
                </c:pt>
                <c:pt idx="1">
                  <c:v>26.904599999999999</c:v>
                </c:pt>
                <c:pt idx="3">
                  <c:v>30</c:v>
                </c:pt>
                <c:pt idx="4">
                  <c:v>30.618300000000001</c:v>
                </c:pt>
                <c:pt idx="6">
                  <c:v>24.544699999999999</c:v>
                </c:pt>
                <c:pt idx="7">
                  <c:v>26.438600000000001</c:v>
                </c:pt>
                <c:pt idx="9">
                  <c:v>32.639200000000002</c:v>
                </c:pt>
                <c:pt idx="10">
                  <c:v>34.395899999999997</c:v>
                </c:pt>
                <c:pt idx="12">
                  <c:v>25.826599999999999</c:v>
                </c:pt>
                <c:pt idx="13">
                  <c:v>28.02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4-CB7D-4EC2-93E8-9434F3E35D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9148544"/>
        <c:axId val="39158528"/>
      </c:barChart>
      <c:catAx>
        <c:axId val="39148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158528"/>
        <c:crosses val="autoZero"/>
        <c:auto val="1"/>
        <c:lblAlgn val="ctr"/>
        <c:lblOffset val="100"/>
        <c:noMultiLvlLbl val="0"/>
      </c:catAx>
      <c:valAx>
        <c:axId val="391585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</a:t>
                </a:r>
                <a:r>
                  <a:rPr lang="en-US" sz="14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ayers</a:t>
                </a:r>
                <a:endParaRPr lang="he-IL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14854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292621056861563"/>
          <c:y val="4.5100452744765131E-2"/>
          <c:w val="0.81198739200321479"/>
          <c:h val="0.8924594416147896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rgbClr val="0000FF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AB4-441D-8D87-81A5E97FDEAF}"/>
              </c:ext>
            </c:extLst>
          </c:dPt>
          <c:dPt>
            <c:idx val="1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31FD-479D-B30A-643E65A1E5F3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AB4-441D-8D87-81A5E97FDEAF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A-31FD-479D-B30A-643E65A1E5F3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AB4-441D-8D87-81A5E97FDEAF}"/>
              </c:ext>
            </c:extLst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C-31FD-479D-B30A-643E65A1E5F3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6AB4-441D-8D87-81A5E97FDEAF}"/>
              </c:ext>
            </c:extLst>
          </c:dPt>
          <c:dPt>
            <c:idx val="1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31FD-479D-B30A-643E65A1E5F3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6AB4-441D-8D87-81A5E97FDEAF}"/>
              </c:ext>
            </c:extLst>
          </c:dPt>
          <c:dPt>
            <c:idx val="13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E-31FD-479D-B30A-643E65A1E5F3}"/>
              </c:ext>
            </c:extLst>
          </c:dPt>
          <c:errBars>
            <c:errBarType val="both"/>
            <c:errValType val="cust"/>
            <c:noEndCap val="0"/>
            <c:plus>
              <c:numRef>
                <c:f>גיליון1!$E$38:$E$51</c:f>
                <c:numCache>
                  <c:formatCode>General</c:formatCode>
                  <c:ptCount val="14"/>
                  <c:pt idx="0">
                    <c:v>0.15132999999999974</c:v>
                  </c:pt>
                  <c:pt idx="1">
                    <c:v>0.15129999999999999</c:v>
                  </c:pt>
                  <c:pt idx="3">
                    <c:v>0.71910000000000007</c:v>
                  </c:pt>
                  <c:pt idx="4">
                    <c:v>0.71910000000000007</c:v>
                  </c:pt>
                  <c:pt idx="6">
                    <c:v>8.5430000000000006E-2</c:v>
                  </c:pt>
                  <c:pt idx="7">
                    <c:v>8.5499999999999909E-2</c:v>
                  </c:pt>
                  <c:pt idx="9">
                    <c:v>0.30403000000000002</c:v>
                  </c:pt>
                  <c:pt idx="10">
                    <c:v>0.30399999999999983</c:v>
                  </c:pt>
                  <c:pt idx="12">
                    <c:v>0.2076300000000002</c:v>
                  </c:pt>
                  <c:pt idx="13">
                    <c:v>0.2077</c:v>
                  </c:pt>
                </c:numCache>
              </c:numRef>
            </c:plus>
            <c:minus>
              <c:numRef>
                <c:f>גיליון1!$E$38:$E$51</c:f>
                <c:numCache>
                  <c:formatCode>General</c:formatCode>
                  <c:ptCount val="14"/>
                  <c:pt idx="0">
                    <c:v>0.15132999999999974</c:v>
                  </c:pt>
                  <c:pt idx="1">
                    <c:v>0.15129999999999999</c:v>
                  </c:pt>
                  <c:pt idx="3">
                    <c:v>0.71910000000000007</c:v>
                  </c:pt>
                  <c:pt idx="4">
                    <c:v>0.71910000000000007</c:v>
                  </c:pt>
                  <c:pt idx="6">
                    <c:v>8.5430000000000006E-2</c:v>
                  </c:pt>
                  <c:pt idx="7">
                    <c:v>8.5499999999999909E-2</c:v>
                  </c:pt>
                  <c:pt idx="9">
                    <c:v>0.30403000000000002</c:v>
                  </c:pt>
                  <c:pt idx="10">
                    <c:v>0.30399999999999983</c:v>
                  </c:pt>
                  <c:pt idx="12">
                    <c:v>0.2076300000000002</c:v>
                  </c:pt>
                  <c:pt idx="13">
                    <c:v>0.20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גיליון1!$C$38:$C$51</c:f>
              <c:strCache>
                <c:ptCount val="14"/>
                <c:pt idx="0">
                  <c:v>Barnea_Tirat Zvi</c:v>
                </c:pt>
                <c:pt idx="1">
                  <c:v>Barnea_Tzuba</c:v>
                </c:pt>
                <c:pt idx="3">
                  <c:v>Picholine_Tirat Zvi</c:v>
                </c:pt>
                <c:pt idx="4">
                  <c:v>Picholine_Tzuba</c:v>
                </c:pt>
                <c:pt idx="6">
                  <c:v>Koroneiki_Tirat Zvi</c:v>
                </c:pt>
                <c:pt idx="7">
                  <c:v>Koroneiki_Tzuba</c:v>
                </c:pt>
                <c:pt idx="9">
                  <c:v>Souri_Tirat Zvi</c:v>
                </c:pt>
                <c:pt idx="10">
                  <c:v>Souri_Tzuba</c:v>
                </c:pt>
                <c:pt idx="12">
                  <c:v>Coratina_Tirat Zvi</c:v>
                </c:pt>
                <c:pt idx="13">
                  <c:v>Coratina_Tzuba</c:v>
                </c:pt>
              </c:strCache>
            </c:strRef>
          </c:cat>
          <c:val>
            <c:numRef>
              <c:f>גיליון1!$D$38:$D$51</c:f>
              <c:numCache>
                <c:formatCode>General</c:formatCode>
                <c:ptCount val="14"/>
                <c:pt idx="0">
                  <c:v>1.8986666666666665</c:v>
                </c:pt>
                <c:pt idx="1">
                  <c:v>2.8279999999999998</c:v>
                </c:pt>
                <c:pt idx="3">
                  <c:v>3.3770000000000002</c:v>
                </c:pt>
                <c:pt idx="4">
                  <c:v>4.4990000000000006</c:v>
                </c:pt>
                <c:pt idx="6">
                  <c:v>0.77266666666666683</c:v>
                </c:pt>
                <c:pt idx="7">
                  <c:v>1.3325</c:v>
                </c:pt>
                <c:pt idx="9">
                  <c:v>1.6446666666666667</c:v>
                </c:pt>
                <c:pt idx="10">
                  <c:v>3.1030000000000002</c:v>
                </c:pt>
                <c:pt idx="12">
                  <c:v>1.8086666666666666</c:v>
                </c:pt>
                <c:pt idx="13">
                  <c:v>2.8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6AB4-441D-8D87-81A5E97FDE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9048704"/>
        <c:axId val="39050240"/>
      </c:barChart>
      <c:catAx>
        <c:axId val="39048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050240"/>
        <c:crosses val="autoZero"/>
        <c:auto val="1"/>
        <c:lblAlgn val="ctr"/>
        <c:lblOffset val="100"/>
        <c:tickLblSkip val="2"/>
        <c:tickMarkSkip val="15"/>
        <c:noMultiLvlLbl val="0"/>
      </c:catAx>
      <c:valAx>
        <c:axId val="39050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ruit weight (gr)</a:t>
                </a:r>
                <a:endParaRPr lang="he-IL" sz="14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048704"/>
        <c:crossesAt val="1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007364982281127"/>
          <c:y val="0.10047137856474575"/>
          <c:w val="0.7449751513482008"/>
          <c:h val="0.776856940498709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708-4140-B8DA-0F673FB39C1D}"/>
              </c:ext>
            </c:extLst>
          </c:dPt>
          <c:dPt>
            <c:idx val="1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3708-4140-B8DA-0F673FB39C1D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708-4140-B8DA-0F673FB39C1D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C-3708-4140-B8DA-0F673FB39C1D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3708-4140-B8DA-0F673FB39C1D}"/>
              </c:ext>
            </c:extLst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3708-4140-B8DA-0F673FB39C1D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3708-4140-B8DA-0F673FB39C1D}"/>
              </c:ext>
            </c:extLst>
          </c:dPt>
          <c:dPt>
            <c:idx val="1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E-3708-4140-B8DA-0F673FB39C1D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3708-4140-B8DA-0F673FB39C1D}"/>
              </c:ext>
            </c:extLst>
          </c:dPt>
          <c:dPt>
            <c:idx val="13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3708-4140-B8DA-0F673FB39C1D}"/>
              </c:ext>
            </c:extLst>
          </c:dPt>
          <c:errBars>
            <c:errBarType val="both"/>
            <c:errValType val="cust"/>
            <c:noEndCap val="0"/>
            <c:plus>
              <c:numRef>
                <c:f>September!$F$3:$F$16</c:f>
                <c:numCache>
                  <c:formatCode>General</c:formatCode>
                  <c:ptCount val="14"/>
                  <c:pt idx="0">
                    <c:v>194</c:v>
                  </c:pt>
                  <c:pt idx="1">
                    <c:v>193.98</c:v>
                  </c:pt>
                  <c:pt idx="3">
                    <c:v>219.7</c:v>
                  </c:pt>
                  <c:pt idx="4">
                    <c:v>219.7</c:v>
                  </c:pt>
                  <c:pt idx="6">
                    <c:v>214.58</c:v>
                  </c:pt>
                  <c:pt idx="7">
                    <c:v>214.58</c:v>
                  </c:pt>
                  <c:pt idx="9">
                    <c:v>312.66000000000003</c:v>
                  </c:pt>
                  <c:pt idx="10">
                    <c:v>312.65000000000003</c:v>
                  </c:pt>
                  <c:pt idx="12">
                    <c:v>243.11000000000101</c:v>
                  </c:pt>
                  <c:pt idx="13">
                    <c:v>243.11000000000101</c:v>
                  </c:pt>
                </c:numCache>
              </c:numRef>
            </c:plus>
            <c:minus>
              <c:numRef>
                <c:f>September!$F$3:$F$16</c:f>
                <c:numCache>
                  <c:formatCode>General</c:formatCode>
                  <c:ptCount val="14"/>
                  <c:pt idx="0">
                    <c:v>194</c:v>
                  </c:pt>
                  <c:pt idx="1">
                    <c:v>193.98</c:v>
                  </c:pt>
                  <c:pt idx="3">
                    <c:v>219.7</c:v>
                  </c:pt>
                  <c:pt idx="4">
                    <c:v>219.7</c:v>
                  </c:pt>
                  <c:pt idx="6">
                    <c:v>214.58</c:v>
                  </c:pt>
                  <c:pt idx="7">
                    <c:v>214.58</c:v>
                  </c:pt>
                  <c:pt idx="9">
                    <c:v>312.66000000000003</c:v>
                  </c:pt>
                  <c:pt idx="10">
                    <c:v>312.65000000000003</c:v>
                  </c:pt>
                  <c:pt idx="12">
                    <c:v>243.11000000000101</c:v>
                  </c:pt>
                  <c:pt idx="13">
                    <c:v>243.110000000001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ptember!$A$3:$A$16</c:f>
              <c:strCache>
                <c:ptCount val="13"/>
                <c:pt idx="0">
                  <c:v>Barnea</c:v>
                </c:pt>
                <c:pt idx="3">
                  <c:v>Picholine</c:v>
                </c:pt>
                <c:pt idx="6">
                  <c:v>Koroneiki</c:v>
                </c:pt>
                <c:pt idx="9">
                  <c:v>Souri</c:v>
                </c:pt>
                <c:pt idx="12">
                  <c:v>Coratina</c:v>
                </c:pt>
              </c:strCache>
            </c:strRef>
          </c:cat>
          <c:val>
            <c:numRef>
              <c:f>September!$E$3:$E$16</c:f>
              <c:numCache>
                <c:formatCode>General</c:formatCode>
                <c:ptCount val="14"/>
                <c:pt idx="0">
                  <c:v>4920.8</c:v>
                </c:pt>
                <c:pt idx="1">
                  <c:v>5181.2199999999993</c:v>
                </c:pt>
                <c:pt idx="3">
                  <c:v>4255.7299999999996</c:v>
                </c:pt>
                <c:pt idx="4">
                  <c:v>5148.5999999999995</c:v>
                </c:pt>
                <c:pt idx="6">
                  <c:v>4238.9900000000007</c:v>
                </c:pt>
                <c:pt idx="7">
                  <c:v>5318.42</c:v>
                </c:pt>
                <c:pt idx="9">
                  <c:v>3162.2400000000002</c:v>
                </c:pt>
                <c:pt idx="10">
                  <c:v>3951.65</c:v>
                </c:pt>
                <c:pt idx="12">
                  <c:v>4258.1099999999997</c:v>
                </c:pt>
                <c:pt idx="13">
                  <c:v>5353.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3708-4140-B8DA-0F673FB39C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83504512"/>
        <c:axId val="83506304"/>
      </c:barChart>
      <c:catAx>
        <c:axId val="83504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3506304"/>
        <c:crosses val="autoZero"/>
        <c:auto val="1"/>
        <c:lblAlgn val="ctr"/>
        <c:lblOffset val="100"/>
        <c:noMultiLvlLbl val="0"/>
      </c:catAx>
      <c:valAx>
        <c:axId val="835063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</a:t>
                </a:r>
                <a:r>
                  <a:rPr lang="en-US" sz="14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400" b="1" i="0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ea  (µm</a:t>
                </a:r>
                <a:r>
                  <a:rPr lang="en-US" sz="1400" b="1" i="0" baseline="3000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sz="1400" b="1" i="0" baseline="0" dirty="0" smtClean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he-IL" sz="14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3504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2798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A8F7B846-B10E-40A5-B4A2-020A834E6BBE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2798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83C229AF-AF85-4F0D-BE1E-953DEBC67F9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0324775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0805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21057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04373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69925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38052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15288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28959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59664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90995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74268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77755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72540-4E31-4FA3-B735-DAB6B5767416}" type="datetimeFigureOut">
              <a:rPr lang="he-IL" smtClean="0"/>
              <a:t>כ'/ניס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79E40-5742-4B2C-87D2-F7D10D1BA539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37438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chart" Target="../charts/chart2.xml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תרשים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2399153"/>
              </p:ext>
            </p:extLst>
          </p:nvPr>
        </p:nvGraphicFramePr>
        <p:xfrm>
          <a:off x="7733411" y="2358645"/>
          <a:ext cx="3965867" cy="18606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9" name="TextBox 68"/>
          <p:cNvSpPr txBox="1"/>
          <p:nvPr/>
        </p:nvSpPr>
        <p:spPr>
          <a:xfrm>
            <a:off x="26054" y="10298"/>
            <a:ext cx="3005904" cy="9541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439197" y="16877"/>
            <a:ext cx="166334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zuba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812878" y="16877"/>
            <a:ext cx="164741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rat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vi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629178" y="685212"/>
            <a:ext cx="9244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nea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473064" y="5972094"/>
            <a:ext cx="10695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atina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350404" y="3333523"/>
            <a:ext cx="11807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roneiki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9487" y="338070"/>
            <a:ext cx="1663345" cy="124750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9196" y="5572312"/>
            <a:ext cx="1663345" cy="124750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9342" y="2937700"/>
            <a:ext cx="1663345" cy="124750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2877" y="5572313"/>
            <a:ext cx="1663345" cy="1247509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7087" y="2937700"/>
            <a:ext cx="1663345" cy="1247509"/>
          </a:xfrm>
          <a:prstGeom prst="rect">
            <a:avLst/>
          </a:prstGeom>
        </p:spPr>
      </p:pic>
      <p:pic>
        <p:nvPicPr>
          <p:cNvPr id="28" name="Picture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2878" y="338070"/>
            <a:ext cx="1663345" cy="1247509"/>
          </a:xfrm>
          <a:prstGeom prst="rect">
            <a:avLst/>
          </a:prstGeom>
        </p:spPr>
      </p:pic>
      <p:pic>
        <p:nvPicPr>
          <p:cNvPr id="29" name="Picture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7291" y="1622290"/>
            <a:ext cx="1663200" cy="12474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9486" y="1622290"/>
            <a:ext cx="1663200" cy="1247400"/>
          </a:xfrm>
          <a:prstGeom prst="rect">
            <a:avLst/>
          </a:prstGeom>
        </p:spPr>
      </p:pic>
      <p:sp>
        <p:nvSpPr>
          <p:cNvPr id="31" name="Rectangle 16"/>
          <p:cNvSpPr/>
          <p:nvPr/>
        </p:nvSpPr>
        <p:spPr>
          <a:xfrm>
            <a:off x="1439611" y="2044350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holine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20"/>
          <p:cNvSpPr/>
          <p:nvPr/>
        </p:nvSpPr>
        <p:spPr>
          <a:xfrm>
            <a:off x="1818745" y="4620916"/>
            <a:ext cx="7232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i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Picture 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7087" y="4261432"/>
            <a:ext cx="1663200" cy="1247400"/>
          </a:xfrm>
          <a:prstGeom prst="rect">
            <a:avLst/>
          </a:prstGeom>
        </p:spPr>
      </p:pic>
      <p:pic>
        <p:nvPicPr>
          <p:cNvPr id="34" name="Picture 2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9341" y="4261432"/>
            <a:ext cx="1663200" cy="1247400"/>
          </a:xfrm>
          <a:prstGeom prst="rect">
            <a:avLst/>
          </a:prstGeom>
        </p:spPr>
      </p:pic>
      <p:graphicFrame>
        <p:nvGraphicFramePr>
          <p:cNvPr id="26" name="Chart 25"/>
          <p:cNvGraphicFramePr>
            <a:graphicFrameLocks/>
          </p:cNvGraphicFramePr>
          <p:nvPr>
            <p:extLst/>
          </p:nvPr>
        </p:nvGraphicFramePr>
        <p:xfrm>
          <a:off x="7717679" y="418110"/>
          <a:ext cx="3981600" cy="1753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223227" y="4422774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49" name="TextBox 48"/>
          <p:cNvSpPr txBox="1"/>
          <p:nvPr/>
        </p:nvSpPr>
        <p:spPr>
          <a:xfrm>
            <a:off x="9895055" y="4383053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0" name="TextBox 49"/>
          <p:cNvSpPr txBox="1"/>
          <p:nvPr/>
        </p:nvSpPr>
        <p:spPr>
          <a:xfrm>
            <a:off x="10561662" y="4723690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1" name="TextBox 50"/>
          <p:cNvSpPr txBox="1"/>
          <p:nvPr/>
        </p:nvSpPr>
        <p:spPr>
          <a:xfrm>
            <a:off x="11234665" y="4372713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3" name="TextBox 52"/>
          <p:cNvSpPr txBox="1"/>
          <p:nvPr/>
        </p:nvSpPr>
        <p:spPr>
          <a:xfrm>
            <a:off x="9869229" y="1452903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4" name="TextBox 53"/>
          <p:cNvSpPr txBox="1"/>
          <p:nvPr/>
        </p:nvSpPr>
        <p:spPr>
          <a:xfrm>
            <a:off x="9179580" y="626458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5" name="TextBox 54"/>
          <p:cNvSpPr txBox="1"/>
          <p:nvPr/>
        </p:nvSpPr>
        <p:spPr>
          <a:xfrm>
            <a:off x="8484921" y="1063657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6" name="TextBox 55"/>
          <p:cNvSpPr txBox="1"/>
          <p:nvPr/>
        </p:nvSpPr>
        <p:spPr>
          <a:xfrm>
            <a:off x="10563281" y="990726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sp>
        <p:nvSpPr>
          <p:cNvPr id="57" name="TextBox 56"/>
          <p:cNvSpPr txBox="1"/>
          <p:nvPr/>
        </p:nvSpPr>
        <p:spPr>
          <a:xfrm>
            <a:off x="11260873" y="1065159"/>
            <a:ext cx="139906" cy="276999"/>
          </a:xfrm>
          <a:prstGeom prst="rect">
            <a:avLst/>
          </a:prstGeom>
          <a:noFill/>
        </p:spPr>
        <p:txBody>
          <a:bodyPr wrap="square" lIns="0" tIns="0" rIns="0" bIns="0" rtlCol="1">
            <a:spAutoFit/>
          </a:bodyPr>
          <a:lstStyle/>
          <a:p>
            <a:pPr algn="ctr"/>
            <a:r>
              <a:rPr lang="en-US" dirty="0"/>
              <a:t>*</a:t>
            </a:r>
            <a:endParaRPr lang="he-IL" dirty="0"/>
          </a:p>
        </p:txBody>
      </p:sp>
      <p:grpSp>
        <p:nvGrpSpPr>
          <p:cNvPr id="59" name="Group 58"/>
          <p:cNvGrpSpPr/>
          <p:nvPr/>
        </p:nvGrpSpPr>
        <p:grpSpPr>
          <a:xfrm>
            <a:off x="8532837" y="67145"/>
            <a:ext cx="3313511" cy="213651"/>
            <a:chOff x="8532837" y="67145"/>
            <a:chExt cx="3313511" cy="216024"/>
          </a:xfrm>
        </p:grpSpPr>
        <p:sp>
          <p:nvSpPr>
            <p:cNvPr id="60" name="TextBox 59"/>
            <p:cNvSpPr txBox="1"/>
            <p:nvPr/>
          </p:nvSpPr>
          <p:spPr>
            <a:xfrm>
              <a:off x="8851150" y="67145"/>
              <a:ext cx="2995198" cy="7588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2000" dirty="0" err="1">
                  <a:latin typeface="Times New Roman" pitchFamily="18" charset="0"/>
                  <a:cs typeface="Times New Roman" pitchFamily="18" charset="0"/>
                </a:rPr>
                <a:t>Tirat</a:t>
              </a:r>
              <a:r>
                <a:rPr lang="en-US" sz="2000" dirty="0">
                  <a:latin typeface="Times New Roman" pitchFamily="18" charset="0"/>
                  <a:cs typeface="Times New Roman" pitchFamily="18" charset="0"/>
                </a:rPr>
                <a:t>-Zvi               </a:t>
              </a:r>
              <a:r>
                <a:rPr lang="en-US" sz="2000" dirty="0" err="1">
                  <a:latin typeface="Times New Roman" pitchFamily="18" charset="0"/>
                  <a:cs typeface="Times New Roman" pitchFamily="18" charset="0"/>
                </a:rPr>
                <a:t>Tzuba</a:t>
              </a:r>
              <a:endParaRPr lang="he-IL" sz="20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1" name="Straight Connector 60"/>
            <p:cNvCxnSpPr/>
            <p:nvPr/>
          </p:nvCxnSpPr>
          <p:spPr>
            <a:xfrm flipH="1">
              <a:off x="8532837" y="283169"/>
              <a:ext cx="397893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 flipH="1">
              <a:off x="10396780" y="283169"/>
              <a:ext cx="397893" cy="0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Group 62"/>
          <p:cNvGrpSpPr/>
          <p:nvPr/>
        </p:nvGrpSpPr>
        <p:grpSpPr>
          <a:xfrm>
            <a:off x="4614027" y="6520696"/>
            <a:ext cx="637253" cy="299129"/>
            <a:chOff x="4321483" y="6385481"/>
            <a:chExt cx="637253" cy="299129"/>
          </a:xfrm>
        </p:grpSpPr>
        <p:sp>
          <p:nvSpPr>
            <p:cNvPr id="65" name="TextBox 64"/>
            <p:cNvSpPr txBox="1"/>
            <p:nvPr/>
          </p:nvSpPr>
          <p:spPr>
            <a:xfrm>
              <a:off x="4321483" y="6385481"/>
              <a:ext cx="637253" cy="24622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µm</a:t>
              </a:r>
              <a:endParaRPr lang="he-IL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4" name="Group 63"/>
            <p:cNvGrpSpPr/>
            <p:nvPr/>
          </p:nvGrpSpPr>
          <p:grpSpPr>
            <a:xfrm>
              <a:off x="4505592" y="6591897"/>
              <a:ext cx="252000" cy="92713"/>
              <a:chOff x="6632411" y="5175173"/>
              <a:chExt cx="252000" cy="92713"/>
            </a:xfrm>
          </p:grpSpPr>
          <p:cxnSp>
            <p:nvCxnSpPr>
              <p:cNvPr id="66" name="Straight Connector 65"/>
              <p:cNvCxnSpPr/>
              <p:nvPr/>
            </p:nvCxnSpPr>
            <p:spPr>
              <a:xfrm>
                <a:off x="6632411" y="5219698"/>
                <a:ext cx="25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>
                <a:off x="6876617" y="5175173"/>
                <a:ext cx="0" cy="917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/>
              <p:nvPr/>
            </p:nvCxnSpPr>
            <p:spPr>
              <a:xfrm>
                <a:off x="6637919" y="5176090"/>
                <a:ext cx="0" cy="9179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70" name="תרשים 3"/>
          <p:cNvGraphicFramePr>
            <a:graphicFrameLocks/>
          </p:cNvGraphicFramePr>
          <p:nvPr>
            <p:extLst/>
          </p:nvPr>
        </p:nvGraphicFramePr>
        <p:xfrm>
          <a:off x="7592149" y="4185208"/>
          <a:ext cx="4177063" cy="24016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44" name="TextBox 43"/>
          <p:cNvSpPr txBox="1"/>
          <p:nvPr/>
        </p:nvSpPr>
        <p:spPr>
          <a:xfrm>
            <a:off x="8185692" y="6293631"/>
            <a:ext cx="751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ne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8834370" y="6299179"/>
            <a:ext cx="798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holin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9476795" y="6299523"/>
            <a:ext cx="868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roneiki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0854277" y="6298091"/>
            <a:ext cx="779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atin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0294070" y="6297344"/>
            <a:ext cx="560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i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16579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06</TotalTime>
  <Words>41</Words>
  <Application>Microsoft Office PowerPoint</Application>
  <PresentationFormat>Custom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ora Ben Ari</dc:creator>
  <cp:lastModifiedBy>Rajakumar</cp:lastModifiedBy>
  <cp:revision>112</cp:revision>
  <cp:lastPrinted>2019-07-09T06:55:45Z</cp:lastPrinted>
  <dcterms:created xsi:type="dcterms:W3CDTF">2018-03-06T07:50:21Z</dcterms:created>
  <dcterms:modified xsi:type="dcterms:W3CDTF">2020-04-14T17:33:23Z</dcterms:modified>
</cp:coreProperties>
</file>